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619"/>
    <p:restoredTop sz="92197"/>
  </p:normalViewPr>
  <p:slideViewPr>
    <p:cSldViewPr snapToGrid="0" snapToObjects="1">
      <p:cViewPr varScale="1">
        <p:scale>
          <a:sx n="56" d="100"/>
          <a:sy n="56" d="100"/>
        </p:scale>
        <p:origin x="69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6AD7162-6EA6-5946-8786-EB572FC3FE8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C9A0DAE8-523E-2F4A-895D-84799FE75CE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0630C11-EAC0-4440-B97B-128243A428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1C488-BCE3-504D-83AE-3D10181D5E1D}" type="datetimeFigureOut">
              <a:rPr kumimoji="1" lang="ja-JP" altLang="en-US" smtClean="0"/>
              <a:t>2024/2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E1EA170-365A-3C4B-B348-E9998FFF9B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66C4606-6AAF-1349-9808-5D51FC1D5F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0FFBC-D4C0-0A48-9985-962C9B3C4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89741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FC009B2-5264-1D4C-8BF6-8DB5C7064A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8382361-2814-2448-8C28-9A126934FB5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43F347D-85EA-A248-BA27-FBCE10D47E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1C488-BCE3-504D-83AE-3D10181D5E1D}" type="datetimeFigureOut">
              <a:rPr kumimoji="1" lang="ja-JP" altLang="en-US" smtClean="0"/>
              <a:t>2024/2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64E9B64-8010-ED48-9AA3-CFF3B9876C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1E2035B-118D-F54A-BA24-28CBB2B360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0FFBC-D4C0-0A48-9985-962C9B3C4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48639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07338A2E-F74A-8942-B02E-C4F00F88699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BB4A73B-CC25-A745-9C86-78BAA3D8EC0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00D4ADB-4056-5546-AE22-C40324D35F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1C488-BCE3-504D-83AE-3D10181D5E1D}" type="datetimeFigureOut">
              <a:rPr kumimoji="1" lang="ja-JP" altLang="en-US" smtClean="0"/>
              <a:t>2024/2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913A4D9-9C46-144B-BFE5-E9023A9868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1EFACCF-0661-FF45-A55D-BF73B037BD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0FFBC-D4C0-0A48-9985-962C9B3C4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15626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DEA3111-DE11-E545-9AE1-E09E328196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A217C79-F1AD-2A42-9390-39977350CE3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9B3F9BC-EF95-2B4B-BB5C-CA7CF58B55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1C488-BCE3-504D-83AE-3D10181D5E1D}" type="datetimeFigureOut">
              <a:rPr kumimoji="1" lang="ja-JP" altLang="en-US" smtClean="0"/>
              <a:t>2024/2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7F0C061-0FF9-D349-AAB5-5236911C6F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9864966-A00C-BE4B-B90E-93D5F0D712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0FFBC-D4C0-0A48-9985-962C9B3C4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75038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268DD1A-1A05-F24E-A757-C5E965780F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CC96BAF-FDB0-024C-8418-601F6FA72C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C27A8AA-A280-3F43-BBAC-A2E6FCA7C6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1C488-BCE3-504D-83AE-3D10181D5E1D}" type="datetimeFigureOut">
              <a:rPr kumimoji="1" lang="ja-JP" altLang="en-US" smtClean="0"/>
              <a:t>2024/2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9DE8EA1-A14A-8549-ADBF-F7E87C0851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523EB3F-18F9-1142-AD9E-9ECED6B412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0FFBC-D4C0-0A48-9985-962C9B3C4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94928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C09CC46-7179-D349-A1D1-3CD5F35BD9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3158AA1-2C25-2F4A-B457-6E5DCEB6E06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9957F92-4CFC-694D-AEB7-6FE1AB01D55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B440521-F5CA-5C44-91D4-DE2059C80E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1C488-BCE3-504D-83AE-3D10181D5E1D}" type="datetimeFigureOut">
              <a:rPr kumimoji="1" lang="ja-JP" altLang="en-US" smtClean="0"/>
              <a:t>2024/2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F96B49C-CAF5-5440-A643-A3680EB495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77C10D9-8717-8E40-BF94-9F9FA818C0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0FFBC-D4C0-0A48-9985-962C9B3C4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39211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9EB26B8-E38E-F646-9620-DF7C0D16AA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60EEDC0-7496-444D-A04A-B825C7A635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2ABCDBD-1EC3-8E47-9CD5-A5077C7666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50683966-DE0B-0140-888A-0CCA85FA641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726B6405-241E-C64C-88B6-91CC4F73595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78FB7044-B213-8A46-95E8-0D0B32D2B8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1C488-BCE3-504D-83AE-3D10181D5E1D}" type="datetimeFigureOut">
              <a:rPr kumimoji="1" lang="ja-JP" altLang="en-US" smtClean="0"/>
              <a:t>2024/2/1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0A4332A2-C565-754E-956C-14FDDA1EC7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9049C3FD-B3C6-3946-8CF1-4A2A8CBC15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0FFBC-D4C0-0A48-9985-962C9B3C4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6068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D801C81-0F24-8F4A-AB15-AB18C5FC4B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449748CA-5EC7-8948-900A-66FBE4F9F1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1C488-BCE3-504D-83AE-3D10181D5E1D}" type="datetimeFigureOut">
              <a:rPr kumimoji="1" lang="ja-JP" altLang="en-US" smtClean="0"/>
              <a:t>2024/2/1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5904C2FE-6692-F94F-B030-468C4D6E84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1031C042-D0C0-2149-9713-B594B6007F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0FFBC-D4C0-0A48-9985-962C9B3C4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5641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420DCAC3-9BE7-0B4B-96B3-57D450E961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1C488-BCE3-504D-83AE-3D10181D5E1D}" type="datetimeFigureOut">
              <a:rPr kumimoji="1" lang="ja-JP" altLang="en-US" smtClean="0"/>
              <a:t>2024/2/1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819A78F-D0F0-5A41-8999-791084A753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07848F5A-C4AE-6544-BFE8-769FEF5211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0FFBC-D4C0-0A48-9985-962C9B3C4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76287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9C3FF58-DEAC-0A49-8411-880691A146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D10BDC2-B33F-3349-963A-50FA0A53CDE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A038DAC-A517-914D-86F2-F53F3A28927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9FCBDC3-806D-7642-9BE5-200338486D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1C488-BCE3-504D-83AE-3D10181D5E1D}" type="datetimeFigureOut">
              <a:rPr kumimoji="1" lang="ja-JP" altLang="en-US" smtClean="0"/>
              <a:t>2024/2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91C9485-2695-6543-B699-20B4A657E1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AE39647-DFB2-ED4F-9B55-C5163384BF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0FFBC-D4C0-0A48-9985-962C9B3C4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71565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0C182D4-1088-2045-AE84-E7FFA90B6D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EABCA0E7-3EB2-C149-AA8B-11281A50258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kumimoji="1" lang="ja-JP" altLang="en-US"/>
              <a:t>アイコンをクリックして図を追加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7553001-E5F4-A44E-9131-1681673F3E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7B02DB4-55A3-1C40-9868-FBB323C4E7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1C488-BCE3-504D-83AE-3D10181D5E1D}" type="datetimeFigureOut">
              <a:rPr kumimoji="1" lang="ja-JP" altLang="en-US" smtClean="0"/>
              <a:t>2024/2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B4294C7-1960-CF43-B825-7B6A2234C1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ED9F578-407D-7C45-9E0D-3CA771C824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0FFBC-D4C0-0A48-9985-962C9B3C4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25064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FDAE1B3-A09B-1B48-A297-8E01EB0093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8944210-8667-2045-92F8-82F4A2D7EF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111550D-6142-2C4C-84F8-1AF4EBC509D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  <a:latin typeface="Meiryo" panose="020B0604030504040204" pitchFamily="34" charset="-128"/>
                <a:ea typeface="Meiryo" panose="020B0604030504040204" pitchFamily="34" charset="-128"/>
              </a:defRPr>
            </a:lvl1pPr>
          </a:lstStyle>
          <a:p>
            <a:fld id="{46F1C488-BCE3-504D-83AE-3D10181D5E1D}" type="datetimeFigureOut">
              <a:rPr lang="ja-JP" altLang="en-US" smtClean="0"/>
              <a:pPr/>
              <a:t>2024/2/14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B30E0D6-FE9A-1849-8044-22B197E14B9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  <a:latin typeface="Meiryo" panose="020B0604030504040204" pitchFamily="34" charset="-128"/>
                <a:ea typeface="Meiryo" panose="020B0604030504040204" pitchFamily="34" charset="-128"/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8B97180-1BBC-0049-A536-D9BA9879B97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  <a:latin typeface="Meiryo" panose="020B0604030504040204" pitchFamily="34" charset="-128"/>
                <a:ea typeface="Meiryo" panose="020B0604030504040204" pitchFamily="34" charset="-128"/>
              </a:defRPr>
            </a:lvl1pPr>
          </a:lstStyle>
          <a:p>
            <a:fld id="{69F0FFBC-D4C0-0A48-9985-962C9B3C4CB8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3758144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Meiryo" panose="020B0604030504040204" pitchFamily="34" charset="-128"/>
          <a:ea typeface="Meiryo" panose="020B0604030504040204" pitchFamily="34" charset="-128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Meiryo" panose="020B0604030504040204" pitchFamily="34" charset="-128"/>
          <a:ea typeface="Meiryo" panose="020B0604030504040204" pitchFamily="34" charset="-128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図 9">
            <a:extLst>
              <a:ext uri="{FF2B5EF4-FFF2-40B4-BE49-F238E27FC236}">
                <a16:creationId xmlns:a16="http://schemas.microsoft.com/office/drawing/2014/main" id="{5EF31837-EB66-AF4B-A496-793899060A2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36794" y="40707"/>
            <a:ext cx="4377421" cy="3183579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342B52B6-13D4-7943-8CC7-511FBEC9204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01955" y="100404"/>
            <a:ext cx="4285524" cy="3116744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2F2B7D45-7FFF-B941-8C3D-54849286E04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04085" y="3471001"/>
            <a:ext cx="4310130" cy="3134640"/>
          </a:xfrm>
          <a:prstGeom prst="rect">
            <a:avLst/>
          </a:prstGeom>
        </p:spPr>
      </p:pic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94ED8FB2-D0C5-9A4B-B72C-616811C0E31F}"/>
              </a:ext>
            </a:extLst>
          </p:cNvPr>
          <p:cNvSpPr/>
          <p:nvPr/>
        </p:nvSpPr>
        <p:spPr>
          <a:xfrm>
            <a:off x="1433147" y="3119714"/>
            <a:ext cx="3960742" cy="31846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Intact PTH </a:t>
            </a:r>
            <a:r>
              <a:rPr kumimoji="1" lang="en-US" altLang="ja-JP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evels (</a:t>
            </a:r>
            <a:r>
              <a:rPr kumimoji="1" lang="en-US" altLang="ja-JP" sz="16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g</a:t>
            </a:r>
            <a:r>
              <a:rPr kumimoji="1" lang="en-US" altLang="ja-JP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/mL)</a:t>
            </a:r>
            <a:endParaRPr kumimoji="1" lang="ja-JP" altLang="en-US" sz="16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A7716D06-C91A-4446-8348-AF8971CF42CB}"/>
              </a:ext>
            </a:extLst>
          </p:cNvPr>
          <p:cNvSpPr/>
          <p:nvPr/>
        </p:nvSpPr>
        <p:spPr>
          <a:xfrm>
            <a:off x="6526566" y="3182926"/>
            <a:ext cx="3660913" cy="1903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AP levels </a:t>
            </a:r>
            <a:r>
              <a:rPr kumimoji="1" lang="en-US" altLang="ja-JP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sz="16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kumimoji="1" lang="en-US" altLang="ja-JP" sz="16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kumimoji="1" lang="en-US" altLang="ja-JP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/L)</a:t>
            </a:r>
            <a:endParaRPr kumimoji="1" lang="ja-JP" altLang="en-US" sz="16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ECA08A1C-FA2D-E44C-9606-37B115948C1C}"/>
              </a:ext>
            </a:extLst>
          </p:cNvPr>
          <p:cNvSpPr/>
          <p:nvPr/>
        </p:nvSpPr>
        <p:spPr>
          <a:xfrm>
            <a:off x="1260867" y="6532827"/>
            <a:ext cx="4305300" cy="21126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RACP-5b </a:t>
            </a:r>
            <a:r>
              <a:rPr kumimoji="1" lang="en-US" altLang="ja-JP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evels (</a:t>
            </a:r>
            <a:r>
              <a:rPr kumimoji="1" lang="en-US" altLang="ja-JP" sz="16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U</a:t>
            </a:r>
            <a:r>
              <a:rPr kumimoji="1" lang="en-US" altLang="ja-JP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altLang="ja-JP" sz="16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kumimoji="1" lang="en-US" altLang="ja-JP" sz="16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r>
              <a:rPr kumimoji="1" lang="en-US" altLang="ja-JP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6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75C74EFF-F2BA-044C-81E9-DD1F593298D7}"/>
              </a:ext>
            </a:extLst>
          </p:cNvPr>
          <p:cNvSpPr txBox="1"/>
          <p:nvPr/>
        </p:nvSpPr>
        <p:spPr>
          <a:xfrm>
            <a:off x="5681521" y="5209388"/>
            <a:ext cx="4505958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X, Maximum</a:t>
            </a:r>
          </a:p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, Calcium</a:t>
            </a:r>
          </a:p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TH, Parathyroid hormone</a:t>
            </a:r>
          </a:p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P, Bone specific alkaline phosphatase </a:t>
            </a:r>
          </a:p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CP-5b, Tartrate-Resistant Acid Phosphatase-5b 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C8691990-E8FB-CC40-94B7-370C14BF6303}"/>
              </a:ext>
            </a:extLst>
          </p:cNvPr>
          <p:cNvSpPr txBox="1"/>
          <p:nvPr/>
        </p:nvSpPr>
        <p:spPr>
          <a:xfrm rot="16200000">
            <a:off x="-445427" y="1321811"/>
            <a:ext cx="230223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x decrease of </a:t>
            </a:r>
          </a:p>
          <a:p>
            <a:pPr algn="ctr"/>
            <a:r>
              <a:rPr lang="en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cted</a:t>
            </a:r>
            <a:r>
              <a:rPr lang="en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a levels (mg/</a:t>
            </a:r>
            <a:r>
              <a:rPr lang="en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L</a:t>
            </a:r>
            <a:r>
              <a:rPr lang="en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E87568F3-1E82-254D-BAB3-B12FB0B22ACF}"/>
              </a:ext>
            </a:extLst>
          </p:cNvPr>
          <p:cNvSpPr txBox="1"/>
          <p:nvPr/>
        </p:nvSpPr>
        <p:spPr>
          <a:xfrm>
            <a:off x="10695545" y="2477297"/>
            <a:ext cx="1616587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Correlations between each variable and maximum corrected Ca decrease until 30 days</a:t>
            </a:r>
            <a:endParaRPr kumimoji="1" lang="ja-JP" altLang="en-US" u="sng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005DA4A9-1965-AB46-9B65-80F998647024}"/>
              </a:ext>
            </a:extLst>
          </p:cNvPr>
          <p:cNvSpPr txBox="1"/>
          <p:nvPr/>
        </p:nvSpPr>
        <p:spPr>
          <a:xfrm rot="16200000">
            <a:off x="-538003" y="4746887"/>
            <a:ext cx="249940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x decrease of </a:t>
            </a:r>
          </a:p>
          <a:p>
            <a:pPr algn="ctr"/>
            <a:r>
              <a:rPr lang="en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cted Ca levels (mg/</a:t>
            </a:r>
            <a:r>
              <a:rPr lang="en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L</a:t>
            </a:r>
            <a:r>
              <a:rPr lang="en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2487C841-AA3D-E64A-8A38-7265855893A2}"/>
              </a:ext>
            </a:extLst>
          </p:cNvPr>
          <p:cNvSpPr txBox="1"/>
          <p:nvPr/>
        </p:nvSpPr>
        <p:spPr>
          <a:xfrm rot="16200000">
            <a:off x="4446835" y="1142349"/>
            <a:ext cx="2448107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x decrease of </a:t>
            </a:r>
          </a:p>
          <a:p>
            <a:pPr algn="ctr"/>
            <a:r>
              <a:rPr lang="en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cted Ca levels(mg/</a:t>
            </a:r>
            <a:r>
              <a:rPr lang="en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L</a:t>
            </a:r>
            <a:r>
              <a:rPr lang="en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87BAD681-BF6B-5C4C-8FE7-43531F46A6FE}"/>
              </a:ext>
            </a:extLst>
          </p:cNvPr>
          <p:cNvSpPr txBox="1"/>
          <p:nvPr/>
        </p:nvSpPr>
        <p:spPr>
          <a:xfrm>
            <a:off x="2490937" y="5864195"/>
            <a:ext cx="26287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coefficient = 0.14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F3C28807-6702-6947-BAAF-953802B01584}"/>
              </a:ext>
            </a:extLst>
          </p:cNvPr>
          <p:cNvSpPr txBox="1"/>
          <p:nvPr/>
        </p:nvSpPr>
        <p:spPr>
          <a:xfrm>
            <a:off x="2456473" y="2385150"/>
            <a:ext cx="26976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coefficient = -0.22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63EFE706-13CE-BB4C-8963-15090C843B3B}"/>
              </a:ext>
            </a:extLst>
          </p:cNvPr>
          <p:cNvSpPr txBox="1"/>
          <p:nvPr/>
        </p:nvSpPr>
        <p:spPr>
          <a:xfrm>
            <a:off x="7380585" y="2385150"/>
            <a:ext cx="26287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coefficient = 0.19</a:t>
            </a:r>
          </a:p>
        </p:txBody>
      </p:sp>
    </p:spTree>
    <p:extLst>
      <p:ext uri="{BB962C8B-B14F-4D97-AF65-F5344CB8AC3E}">
        <p14:creationId xmlns:p14="http://schemas.microsoft.com/office/powerpoint/2010/main" val="121456800"/>
      </p:ext>
    </p:extLst>
  </p:cSld>
  <p:clrMapOvr>
    <a:masterClrMapping/>
  </p:clrMapOvr>
</p:sld>
</file>

<file path=ppt/theme/theme1.xml><?xml version="1.0" encoding="utf-8"?>
<a:theme xmlns:a="http://schemas.openxmlformats.org/drawingml/2006/main" name="テーマ1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テーマ1" id="{C9DF33FA-C216-FC4A-9A77-53C2FAB637B0}" vid="{D8C45B50-8ECB-684F-B49B-15C1275691BF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テーマ1</Template>
  <TotalTime>629</TotalTime>
  <Words>106</Words>
  <Application>Microsoft Macintosh PowerPoint</Application>
  <PresentationFormat>ワイド画面</PresentationFormat>
  <Paragraphs>1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Meiryo</vt:lpstr>
      <vt:lpstr>游ゴシック</vt:lpstr>
      <vt:lpstr>Arial</vt:lpstr>
      <vt:lpstr>Times New Roman</vt:lpstr>
      <vt:lpstr>テーマ1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加藤 一彦</dc:creator>
  <cp:lastModifiedBy>加藤 一彦</cp:lastModifiedBy>
  <cp:revision>96</cp:revision>
  <cp:lastPrinted>2023-12-21T08:00:09Z</cp:lastPrinted>
  <dcterms:created xsi:type="dcterms:W3CDTF">2023-10-10T05:47:52Z</dcterms:created>
  <dcterms:modified xsi:type="dcterms:W3CDTF">2024-02-14T02:56:54Z</dcterms:modified>
</cp:coreProperties>
</file>